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84" r:id="rId2"/>
  </p:sldIdLst>
  <p:sldSz cx="6858000" cy="13560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229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34" autoAdjust="0"/>
    <p:restoredTop sz="93438" autoAdjust="0"/>
  </p:normalViewPr>
  <p:slideViewPr>
    <p:cSldViewPr snapToGrid="0" snapToObjects="1">
      <p:cViewPr>
        <p:scale>
          <a:sx n="88" d="100"/>
          <a:sy n="88" d="100"/>
        </p:scale>
        <p:origin x="271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>
      <p:cViewPr>
        <p:scale>
          <a:sx n="295" d="100"/>
          <a:sy n="295" d="100"/>
        </p:scale>
        <p:origin x="-1944" y="-220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89E5FE-6249-2844-8B90-606D05ED173F}" type="datetimeFigureOut">
              <a:rPr lang="en-US" smtClean="0"/>
              <a:t>11/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49538" y="1143000"/>
            <a:ext cx="1558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D27E95-6C1E-4B4D-A2C2-DB2752A99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4666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219265"/>
            <a:ext cx="5829300" cy="472103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122363"/>
            <a:ext cx="5143500" cy="327396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693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836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21967"/>
            <a:ext cx="1478756" cy="114918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21967"/>
            <a:ext cx="4350544" cy="114918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681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540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380693"/>
            <a:ext cx="5915025" cy="564075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9074816"/>
            <a:ext cx="5915025" cy="29663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991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609835"/>
            <a:ext cx="2914650" cy="8603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609835"/>
            <a:ext cx="2914650" cy="8603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517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21970"/>
            <a:ext cx="5915025" cy="26210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324189"/>
            <a:ext cx="2901255" cy="162913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953322"/>
            <a:ext cx="2901255" cy="72855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324189"/>
            <a:ext cx="2915543" cy="162913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953322"/>
            <a:ext cx="2915543" cy="72855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701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281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9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4028"/>
            <a:ext cx="2211884" cy="316409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952453"/>
            <a:ext cx="3471863" cy="963669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68128"/>
            <a:ext cx="2211884" cy="753670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41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4028"/>
            <a:ext cx="2211884" cy="316409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952453"/>
            <a:ext cx="3471863" cy="963669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68128"/>
            <a:ext cx="2211884" cy="753670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764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21970"/>
            <a:ext cx="5915025" cy="26210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609835"/>
            <a:ext cx="5915025" cy="8603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568508"/>
            <a:ext cx="1543050" cy="721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C1D55-62F1-4049-A26A-C002C88CC1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568508"/>
            <a:ext cx="2314575" cy="721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568508"/>
            <a:ext cx="1543050" cy="721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69AAE-1A53-B04D-9872-7A6A868040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495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940D5FD8-5B0C-C156-448B-F1E7B162F8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431" y="1284161"/>
            <a:ext cx="2753717" cy="1475205"/>
          </a:xfrm>
          <a:prstGeom prst="rect">
            <a:avLst/>
          </a:prstGeom>
        </p:spPr>
      </p:pic>
      <p:sp>
        <p:nvSpPr>
          <p:cNvPr id="4" name="TextBox 59">
            <a:extLst>
              <a:ext uri="{FF2B5EF4-FFF2-40B4-BE49-F238E27FC236}">
                <a16:creationId xmlns:a16="http://schemas.microsoft.com/office/drawing/2014/main" id="{69EFBB2A-ACBA-4777-E553-BF5617C0ADDB}"/>
              </a:ext>
            </a:extLst>
          </p:cNvPr>
          <p:cNvSpPr txBox="1"/>
          <p:nvPr/>
        </p:nvSpPr>
        <p:spPr>
          <a:xfrm>
            <a:off x="133546" y="487250"/>
            <a:ext cx="124459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8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31">
            <a:extLst>
              <a:ext uri="{FF2B5EF4-FFF2-40B4-BE49-F238E27FC236}">
                <a16:creationId xmlns:a16="http://schemas.microsoft.com/office/drawing/2014/main" id="{5711663E-879B-E484-0B31-55B3AC22735D}"/>
              </a:ext>
            </a:extLst>
          </p:cNvPr>
          <p:cNvSpPr/>
          <p:nvPr/>
        </p:nvSpPr>
        <p:spPr>
          <a:xfrm>
            <a:off x="1219519" y="1864541"/>
            <a:ext cx="1471225" cy="31261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322A14B-D0E7-DAE9-A1C0-A6632E63FB2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21978"/>
          <a:stretch/>
        </p:blipFill>
        <p:spPr>
          <a:xfrm>
            <a:off x="217881" y="2427042"/>
            <a:ext cx="2725675" cy="167818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C851B36-1AE6-DD25-5B81-841A1C15CB7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9716" b="36914"/>
          <a:stretch/>
        </p:blipFill>
        <p:spPr>
          <a:xfrm>
            <a:off x="3909158" y="1427517"/>
            <a:ext cx="2753717" cy="792873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D8FA8A54-A49D-AA05-7F66-04CD0459BD4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23173" b="25136"/>
          <a:stretch/>
        </p:blipFill>
        <p:spPr>
          <a:xfrm>
            <a:off x="3909158" y="2549332"/>
            <a:ext cx="2753717" cy="1158173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DF55F65D-A2AF-44C6-B824-95F60FEF4E1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26445" b="28630"/>
          <a:stretch/>
        </p:blipFill>
        <p:spPr>
          <a:xfrm>
            <a:off x="4108235" y="4174613"/>
            <a:ext cx="2792033" cy="102060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3940DE0B-AC9D-45B2-B8D7-DDD9FBDB727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2341" y="4444215"/>
            <a:ext cx="2418685" cy="1007786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A34F1E6A-E53D-AD36-71A6-7908FB68752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2331" y="6144876"/>
            <a:ext cx="2520429" cy="1222553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DB79E3D4-8306-0D7F-88CE-BF45DB000A97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t="25628" b="18877"/>
          <a:stretch/>
        </p:blipFill>
        <p:spPr>
          <a:xfrm>
            <a:off x="4108235" y="6070086"/>
            <a:ext cx="2707494" cy="1222553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B5958AB5-86B1-1A64-2A68-FA59A77D218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0047" y="8000360"/>
            <a:ext cx="2274668" cy="1339585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5CD00ED8-2E90-D0A3-A9B8-BE377D2F9C86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t="23058" b="26516"/>
          <a:stretch/>
        </p:blipFill>
        <p:spPr>
          <a:xfrm>
            <a:off x="3980866" y="8167510"/>
            <a:ext cx="2962232" cy="1215412"/>
          </a:xfrm>
          <a:prstGeom prst="rect">
            <a:avLst/>
          </a:prstGeom>
        </p:spPr>
      </p:pic>
      <p:sp>
        <p:nvSpPr>
          <p:cNvPr id="2" name="Rectangle 31">
            <a:extLst>
              <a:ext uri="{FF2B5EF4-FFF2-40B4-BE49-F238E27FC236}">
                <a16:creationId xmlns:a16="http://schemas.microsoft.com/office/drawing/2014/main" id="{949C2476-0A7C-6A75-CCCC-7F5110A4915D}"/>
              </a:ext>
            </a:extLst>
          </p:cNvPr>
          <p:cNvSpPr/>
          <p:nvPr/>
        </p:nvSpPr>
        <p:spPr>
          <a:xfrm>
            <a:off x="1219520" y="3417661"/>
            <a:ext cx="1471225" cy="31261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31">
            <a:extLst>
              <a:ext uri="{FF2B5EF4-FFF2-40B4-BE49-F238E27FC236}">
                <a16:creationId xmlns:a16="http://schemas.microsoft.com/office/drawing/2014/main" id="{D27C06F1-C83F-500F-5C8C-CACEF65C3FF7}"/>
              </a:ext>
            </a:extLst>
          </p:cNvPr>
          <p:cNvSpPr/>
          <p:nvPr/>
        </p:nvSpPr>
        <p:spPr>
          <a:xfrm>
            <a:off x="1224496" y="4882600"/>
            <a:ext cx="1471225" cy="31261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31">
            <a:extLst>
              <a:ext uri="{FF2B5EF4-FFF2-40B4-BE49-F238E27FC236}">
                <a16:creationId xmlns:a16="http://schemas.microsoft.com/office/drawing/2014/main" id="{D4869FC8-268D-B263-577A-C0B9FF01E5EB}"/>
              </a:ext>
            </a:extLst>
          </p:cNvPr>
          <p:cNvSpPr/>
          <p:nvPr/>
        </p:nvSpPr>
        <p:spPr>
          <a:xfrm>
            <a:off x="1219519" y="6681362"/>
            <a:ext cx="1471225" cy="31261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31">
            <a:extLst>
              <a:ext uri="{FF2B5EF4-FFF2-40B4-BE49-F238E27FC236}">
                <a16:creationId xmlns:a16="http://schemas.microsoft.com/office/drawing/2014/main" id="{A945625A-D352-DE20-A43F-8E224474ACC5}"/>
              </a:ext>
            </a:extLst>
          </p:cNvPr>
          <p:cNvSpPr/>
          <p:nvPr/>
        </p:nvSpPr>
        <p:spPr>
          <a:xfrm>
            <a:off x="1219519" y="8517238"/>
            <a:ext cx="1471225" cy="31261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E25221C-4AAF-2712-F107-2E009D23C31D}"/>
              </a:ext>
            </a:extLst>
          </p:cNvPr>
          <p:cNvSpPr txBox="1"/>
          <p:nvPr/>
        </p:nvSpPr>
        <p:spPr>
          <a:xfrm>
            <a:off x="-81842" y="1816369"/>
            <a:ext cx="994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LaminB1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E9E5F09-A25B-9076-2BF0-B2A02D4316AC}"/>
              </a:ext>
            </a:extLst>
          </p:cNvPr>
          <p:cNvSpPr txBox="1"/>
          <p:nvPr/>
        </p:nvSpPr>
        <p:spPr>
          <a:xfrm>
            <a:off x="-27474" y="3478516"/>
            <a:ext cx="760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OXIV</a:t>
            </a:r>
            <a:endParaRPr kumimoji="1"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3B18878-7F37-9477-198F-0E45FE61FCC3}"/>
              </a:ext>
            </a:extLst>
          </p:cNvPr>
          <p:cNvSpPr txBox="1"/>
          <p:nvPr/>
        </p:nvSpPr>
        <p:spPr>
          <a:xfrm>
            <a:off x="-27474" y="4846285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Tubulin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DB9163C-1A10-1137-B9AD-515B527FE9EA}"/>
              </a:ext>
            </a:extLst>
          </p:cNvPr>
          <p:cNvSpPr txBox="1"/>
          <p:nvPr/>
        </p:nvSpPr>
        <p:spPr>
          <a:xfrm>
            <a:off x="-6471" y="6681362"/>
            <a:ext cx="631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P-GP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3B94484-900F-E950-D853-CC8A256666C2}"/>
              </a:ext>
            </a:extLst>
          </p:cNvPr>
          <p:cNvSpPr txBox="1"/>
          <p:nvPr/>
        </p:nvSpPr>
        <p:spPr>
          <a:xfrm>
            <a:off x="-27475" y="8485486"/>
            <a:ext cx="993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SLC13A2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2186942-BD01-4D22-B475-04AD8E47BAA6}"/>
              </a:ext>
            </a:extLst>
          </p:cNvPr>
          <p:cNvSpPr txBox="1"/>
          <p:nvPr/>
        </p:nvSpPr>
        <p:spPr>
          <a:xfrm>
            <a:off x="4648903" y="667980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180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17" name="直线连接符 16">
            <a:extLst>
              <a:ext uri="{FF2B5EF4-FFF2-40B4-BE49-F238E27FC236}">
                <a16:creationId xmlns:a16="http://schemas.microsoft.com/office/drawing/2014/main" id="{B66F6292-6643-9674-FDC7-FB9D779EA5BB}"/>
              </a:ext>
            </a:extLst>
          </p:cNvPr>
          <p:cNvCxnSpPr>
            <a:cxnSpLocks/>
          </p:cNvCxnSpPr>
          <p:nvPr/>
        </p:nvCxnSpPr>
        <p:spPr>
          <a:xfrm>
            <a:off x="5166216" y="6827644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线连接符 17">
            <a:extLst>
              <a:ext uri="{FF2B5EF4-FFF2-40B4-BE49-F238E27FC236}">
                <a16:creationId xmlns:a16="http://schemas.microsoft.com/office/drawing/2014/main" id="{413C85CF-251C-968C-0A89-1756C44E59BE}"/>
              </a:ext>
            </a:extLst>
          </p:cNvPr>
          <p:cNvCxnSpPr>
            <a:cxnSpLocks/>
          </p:cNvCxnSpPr>
          <p:nvPr/>
        </p:nvCxnSpPr>
        <p:spPr>
          <a:xfrm>
            <a:off x="5070966" y="8996169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20BE7DF-5807-6F50-587B-3F3E732C932B}"/>
              </a:ext>
            </a:extLst>
          </p:cNvPr>
          <p:cNvSpPr txBox="1"/>
          <p:nvPr/>
        </p:nvSpPr>
        <p:spPr>
          <a:xfrm>
            <a:off x="4591538" y="883127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60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91CC8CE5-29D9-50D4-C4E9-9551F7B49111}"/>
              </a:ext>
            </a:extLst>
          </p:cNvPr>
          <p:cNvCxnSpPr>
            <a:cxnSpLocks/>
          </p:cNvCxnSpPr>
          <p:nvPr/>
        </p:nvCxnSpPr>
        <p:spPr>
          <a:xfrm>
            <a:off x="4916765" y="4695406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67A200E-4D1A-2542-18EA-8C75A00BA883}"/>
              </a:ext>
            </a:extLst>
          </p:cNvPr>
          <p:cNvSpPr txBox="1"/>
          <p:nvPr/>
        </p:nvSpPr>
        <p:spPr>
          <a:xfrm>
            <a:off x="4396598" y="450024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60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23" name="直线连接符 22">
            <a:extLst>
              <a:ext uri="{FF2B5EF4-FFF2-40B4-BE49-F238E27FC236}">
                <a16:creationId xmlns:a16="http://schemas.microsoft.com/office/drawing/2014/main" id="{5C10D0E9-F4E8-BAA3-28F8-1A15F2A8FFD7}"/>
              </a:ext>
            </a:extLst>
          </p:cNvPr>
          <p:cNvCxnSpPr>
            <a:cxnSpLocks/>
          </p:cNvCxnSpPr>
          <p:nvPr/>
        </p:nvCxnSpPr>
        <p:spPr>
          <a:xfrm>
            <a:off x="4916765" y="3315568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线连接符 23">
            <a:extLst>
              <a:ext uri="{FF2B5EF4-FFF2-40B4-BE49-F238E27FC236}">
                <a16:creationId xmlns:a16="http://schemas.microsoft.com/office/drawing/2014/main" id="{6114B27C-7939-37C0-1E5C-A0086E1E65DD}"/>
              </a:ext>
            </a:extLst>
          </p:cNvPr>
          <p:cNvCxnSpPr>
            <a:cxnSpLocks/>
          </p:cNvCxnSpPr>
          <p:nvPr/>
        </p:nvCxnSpPr>
        <p:spPr>
          <a:xfrm>
            <a:off x="4916033" y="3171406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线连接符 27">
            <a:extLst>
              <a:ext uri="{FF2B5EF4-FFF2-40B4-BE49-F238E27FC236}">
                <a16:creationId xmlns:a16="http://schemas.microsoft.com/office/drawing/2014/main" id="{5DFFA6BA-1550-0AC1-3C03-D223F2201062}"/>
              </a:ext>
            </a:extLst>
          </p:cNvPr>
          <p:cNvCxnSpPr>
            <a:cxnSpLocks/>
          </p:cNvCxnSpPr>
          <p:nvPr/>
        </p:nvCxnSpPr>
        <p:spPr>
          <a:xfrm>
            <a:off x="5069165" y="3467968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98A9E80B-575D-1D5B-8E16-DBA9EB6C9C68}"/>
              </a:ext>
            </a:extLst>
          </p:cNvPr>
          <p:cNvSpPr txBox="1"/>
          <p:nvPr/>
        </p:nvSpPr>
        <p:spPr>
          <a:xfrm>
            <a:off x="4525477" y="318318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15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4B27ABF-93E6-79A6-3E07-E0D9DA2F930E}"/>
              </a:ext>
            </a:extLst>
          </p:cNvPr>
          <p:cNvSpPr txBox="1"/>
          <p:nvPr/>
        </p:nvSpPr>
        <p:spPr>
          <a:xfrm>
            <a:off x="4525477" y="298674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25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cxnSp>
        <p:nvCxnSpPr>
          <p:cNvPr id="35" name="直线连接符 34">
            <a:extLst>
              <a:ext uri="{FF2B5EF4-FFF2-40B4-BE49-F238E27FC236}">
                <a16:creationId xmlns:a16="http://schemas.microsoft.com/office/drawing/2014/main" id="{9C430108-C34E-DC3E-5F39-13E04B8B350B}"/>
              </a:ext>
            </a:extLst>
          </p:cNvPr>
          <p:cNvCxnSpPr>
            <a:cxnSpLocks/>
          </p:cNvCxnSpPr>
          <p:nvPr/>
        </p:nvCxnSpPr>
        <p:spPr>
          <a:xfrm>
            <a:off x="4776879" y="1967616"/>
            <a:ext cx="562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428E7026-9A24-988A-6874-C5446EAAFCD3}"/>
              </a:ext>
            </a:extLst>
          </p:cNvPr>
          <p:cNvSpPr txBox="1"/>
          <p:nvPr/>
        </p:nvSpPr>
        <p:spPr>
          <a:xfrm>
            <a:off x="4403315" y="179729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chemeClr val="bg1"/>
                </a:solidFill>
              </a:rPr>
              <a:t>60</a:t>
            </a:r>
            <a:endParaRPr kumimoji="1" lang="zh-CN" altLang="en-US" dirty="0">
              <a:solidFill>
                <a:schemeClr val="bg1"/>
              </a:solidFill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28734CD-E887-A3A6-D0F0-C7548C5D768A}"/>
              </a:ext>
            </a:extLst>
          </p:cNvPr>
          <p:cNvSpPr txBox="1"/>
          <p:nvPr/>
        </p:nvSpPr>
        <p:spPr>
          <a:xfrm rot="18570676">
            <a:off x="1142140" y="1215295"/>
            <a:ext cx="9268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Whole lysate</a:t>
            </a:r>
            <a:endParaRPr kumimoji="1" lang="zh-CN" altLang="en-US" sz="11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4948BFE-C4A9-BB2C-B899-EF97193AEAEB}"/>
              </a:ext>
            </a:extLst>
          </p:cNvPr>
          <p:cNvSpPr txBox="1"/>
          <p:nvPr/>
        </p:nvSpPr>
        <p:spPr>
          <a:xfrm rot="18570676">
            <a:off x="1560676" y="1234959"/>
            <a:ext cx="5437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Nuclei</a:t>
            </a:r>
            <a:endParaRPr kumimoji="1" lang="zh-CN" altLang="en-US" sz="11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B5E92109-2C9F-7E28-7E7A-607F655F7F67}"/>
              </a:ext>
            </a:extLst>
          </p:cNvPr>
          <p:cNvSpPr txBox="1"/>
          <p:nvPr/>
        </p:nvSpPr>
        <p:spPr>
          <a:xfrm rot="18570676">
            <a:off x="1674695" y="1195532"/>
            <a:ext cx="9925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Mitochondria</a:t>
            </a:r>
            <a:endParaRPr kumimoji="1" lang="zh-CN" altLang="en-US" sz="11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674D094B-97B1-58FD-0107-56FFA50E6B8E}"/>
              </a:ext>
            </a:extLst>
          </p:cNvPr>
          <p:cNvSpPr txBox="1"/>
          <p:nvPr/>
        </p:nvSpPr>
        <p:spPr>
          <a:xfrm rot="18570676">
            <a:off x="2112622" y="1258455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Cytosol</a:t>
            </a:r>
            <a:endParaRPr kumimoji="1" lang="zh-CN" altLang="en-US" sz="11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2352CACE-4767-001A-E239-2DEF94883EC5}"/>
              </a:ext>
            </a:extLst>
          </p:cNvPr>
          <p:cNvSpPr txBox="1"/>
          <p:nvPr/>
        </p:nvSpPr>
        <p:spPr>
          <a:xfrm rot="18570676">
            <a:off x="2217541" y="1337861"/>
            <a:ext cx="8226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/>
              <a:t>Membrane</a:t>
            </a:r>
            <a:endParaRPr kumimoji="1"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151530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574</TotalTime>
  <Words>19</Words>
  <Application>Microsoft Macintosh PowerPoint</Application>
  <PresentationFormat>自定义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ong, Jing</dc:creator>
  <cp:lastModifiedBy>Chen Hao</cp:lastModifiedBy>
  <cp:revision>213</cp:revision>
  <dcterms:created xsi:type="dcterms:W3CDTF">2023-10-18T01:28:26Z</dcterms:created>
  <dcterms:modified xsi:type="dcterms:W3CDTF">2024-11-01T00:11:11Z</dcterms:modified>
</cp:coreProperties>
</file>